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86" r:id="rId2"/>
    <p:sldId id="287" r:id="rId3"/>
  </p:sldIdLst>
  <p:sldSz cx="12192000" cy="16256000"/>
  <p:notesSz cx="6858000" cy="9144000"/>
  <p:defaultTextStyle>
    <a:defPPr>
      <a:defRPr lang="en-US"/>
    </a:defPPr>
    <a:lvl1pPr marL="0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1pPr>
    <a:lvl2pPr marL="812729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2pPr>
    <a:lvl3pPr marL="1625458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3pPr>
    <a:lvl4pPr marL="2438187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4pPr>
    <a:lvl5pPr marL="3250916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5pPr>
    <a:lvl6pPr marL="4063644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6pPr>
    <a:lvl7pPr marL="4876373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7pPr>
    <a:lvl8pPr marL="5689102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8pPr>
    <a:lvl9pPr marL="6501831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rothers, Katelyn - (katelyncarothers)" initials="CK(" lastIdx="7" clrIdx="0">
    <p:extLst>
      <p:ext uri="{19B8F6BF-5375-455C-9EA6-DF929625EA0E}">
        <p15:presenceInfo xmlns:p15="http://schemas.microsoft.com/office/powerpoint/2012/main" userId="Carothers, Katelyn - (katelyncarothers)" providerId="None"/>
      </p:ext>
    </p:extLst>
  </p:cmAuthor>
  <p:cmAuthor id="2" name="Viswanathan, VK - (vkv)" initials="VV(" lastIdx="1" clrIdx="1">
    <p:extLst>
      <p:ext uri="{19B8F6BF-5375-455C-9EA6-DF929625EA0E}">
        <p15:presenceInfo xmlns:p15="http://schemas.microsoft.com/office/powerpoint/2012/main" userId="Viswanathan, VK - (vkv)" providerId="None"/>
      </p:ext>
    </p:extLst>
  </p:cmAuthor>
  <p:cmAuthor id="3" name="Andrew Clark" initials="AC" lastIdx="13" clrIdx="2">
    <p:extLst>
      <p:ext uri="{19B8F6BF-5375-455C-9EA6-DF929625EA0E}">
        <p15:presenceInfo xmlns:p15="http://schemas.microsoft.com/office/powerpoint/2012/main" userId="d837cc602894be7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CC168"/>
    <a:srgbClr val="B7B7B7"/>
    <a:srgbClr val="43682B"/>
    <a:srgbClr val="5C5C5C"/>
    <a:srgbClr val="6AAA40"/>
    <a:srgbClr val="A5A5A5"/>
    <a:srgbClr val="6289CE"/>
    <a:srgbClr val="F1975A"/>
    <a:srgbClr val="1B3A71"/>
    <a:srgbClr val="993E0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8344" autoAdjust="0"/>
    <p:restoredTop sz="93831" autoAdjust="0"/>
  </p:normalViewPr>
  <p:slideViewPr>
    <p:cSldViewPr>
      <p:cViewPr>
        <p:scale>
          <a:sx n="60" d="100"/>
          <a:sy n="60" d="100"/>
        </p:scale>
        <p:origin x="2021" y="34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3" d="100"/>
        <a:sy n="193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51EE23-5542-BD4A-B092-111EA22A2ED4}" type="datetimeFigureOut">
              <a:rPr lang="en-US" smtClean="0"/>
              <a:t>1/19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A82413-3FDC-AA46-A2C9-54D5B298CF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3163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1pPr>
    <a:lvl2pPr marL="812729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2pPr>
    <a:lvl3pPr marL="1625458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3pPr>
    <a:lvl4pPr marL="2438187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4pPr>
    <a:lvl5pPr marL="3250916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5pPr>
    <a:lvl6pPr marL="4063644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6pPr>
    <a:lvl7pPr marL="4876373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7pPr>
    <a:lvl8pPr marL="5689102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8pPr>
    <a:lvl9pPr marL="6501831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5049897"/>
            <a:ext cx="10363200" cy="348450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9211733"/>
            <a:ext cx="8534400" cy="415431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1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198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1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606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650998"/>
            <a:ext cx="2743200" cy="1387028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650998"/>
            <a:ext cx="8026400" cy="1387028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1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089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1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101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10445986"/>
            <a:ext cx="10363200" cy="3228622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6889990"/>
            <a:ext cx="10363200" cy="3555999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1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927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3793070"/>
            <a:ext cx="5384800" cy="10728209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3793070"/>
            <a:ext cx="5384800" cy="10728209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1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364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3638786"/>
            <a:ext cx="5386917" cy="1516473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5155259"/>
            <a:ext cx="5386917" cy="9366016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9" y="3638786"/>
            <a:ext cx="5389033" cy="1516473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9" y="5155259"/>
            <a:ext cx="5389033" cy="9366016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1/1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487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1/1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757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1/1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577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2" y="647230"/>
            <a:ext cx="4011084" cy="2754489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647233"/>
            <a:ext cx="6815667" cy="1387404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2" y="3401722"/>
            <a:ext cx="4011084" cy="11119557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1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127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11379200"/>
            <a:ext cx="7315200" cy="1343379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1452504"/>
            <a:ext cx="7315200" cy="9753600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12722579"/>
            <a:ext cx="7315200" cy="1907821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1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704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650994"/>
            <a:ext cx="10972800" cy="27093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3793070"/>
            <a:ext cx="10972800" cy="107282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15066908"/>
            <a:ext cx="284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E54DC5-104E-42C3-8B1B-A4B828B9B3C3}" type="datetimeFigureOut">
              <a:rPr lang="en-US" smtClean="0"/>
              <a:t>1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15066908"/>
            <a:ext cx="3860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15066908"/>
            <a:ext cx="284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765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19170" rtl="0" eaLnBrk="1" latinLnBrk="0" hangingPunct="1"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89" indent="-457189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defTabSz="1219170" rtl="0" eaLnBrk="1" latinLnBrk="0" hangingPunct="1">
        <a:spcBef>
          <a:spcPct val="20000"/>
        </a:spcBef>
        <a:buFont typeface="Arial" panose="020B0604020202020204" pitchFamily="34" charset="0"/>
        <a:buChar char="–"/>
        <a:defRPr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–"/>
        <a:defRPr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»"/>
        <a:defRPr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5731642"/>
              </p:ext>
            </p:extLst>
          </p:nvPr>
        </p:nvGraphicFramePr>
        <p:xfrm>
          <a:off x="812800" y="5588000"/>
          <a:ext cx="10261600" cy="57404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7432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33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848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06400">
                <a:tc>
                  <a:txBody>
                    <a:bodyPr/>
                    <a:lstStyle/>
                    <a:p>
                      <a:pPr algn="l"/>
                      <a:r>
                        <a:rPr lang="en-US" sz="1900" b="1" dirty="0"/>
                        <a:t>Strains</a:t>
                      </a:r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/>
                        <a:t>Strain Number</a:t>
                      </a:r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/>
                        <a:t>Strain Description</a:t>
                      </a:r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8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.</a:t>
                      </a:r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ifficile</a:t>
                      </a:r>
                      <a:endParaRPr lang="en-US" sz="15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400" dirty="0"/>
                    </a:p>
                  </a:txBody>
                  <a:tcPr marL="12700" marR="12700" marT="1270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300" b="1" i="1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/>
                      <a:endParaRPr lang="en-US" sz="1500" dirty="0"/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s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313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sertional inactivation of the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ene in WT BI-1 (RT 027)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pMTL8215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278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wildtype supplied with pMTL82151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pMTL8215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386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supplied with pMTL82151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pMTL8215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390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complemented with pMTL82151 containing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pMTL821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525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wildtype supplied with pMTL82153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pMTL821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529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supplied with pMTL82153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pMTL82153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348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wildtype supplied with pMTL82153 containing BI-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78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(WT)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endParaRPr lang="en-US" sz="2400" dirty="0"/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300" b="1" i="1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317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sertional inactivation of the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ene in WT CDC1 (RT 078)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pMTL8215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399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wildtype supplied with pMTL82151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pMTL8215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382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supplied with pMTL82151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pMTL8215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352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complemented with pMTL82151 containing BI-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pMTL821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517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wildtype supplied with pMTL82153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pMTL821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52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supplied with pMTL82153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pMTL82153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513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wildtype supplied with pMTL82153 containing CDC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endParaRPr lang="en-US" sz="1500" dirty="0"/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45974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. coli</a:t>
                      </a:r>
                    </a:p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43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endParaRPr lang="en-US" sz="1500" dirty="0"/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sed in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. difficile 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njugative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mating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H10B</a:t>
                      </a:r>
                    </a:p>
                  </a:txBody>
                  <a:tcPr marL="12700" marR="12700" marT="12700" marB="0" anchor="b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500" dirty="0"/>
                    </a:p>
                  </a:txBody>
                  <a:tcPr marL="12700" marR="12700" marT="1270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sed in cloning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and maintenance of </a:t>
                      </a:r>
                      <a:r>
                        <a:rPr lang="en-US" sz="15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GemT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Easy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28600" y="1727200"/>
            <a:ext cx="10515600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r>
              <a:rPr lang="en-US" b="1" dirty="0"/>
              <a:t>Table S3.  Strains used in this study</a:t>
            </a:r>
          </a:p>
        </p:txBody>
      </p:sp>
    </p:spTree>
    <p:extLst>
      <p:ext uri="{BB962C8B-B14F-4D97-AF65-F5344CB8AC3E}">
        <p14:creationId xmlns:p14="http://schemas.microsoft.com/office/powerpoint/2010/main" val="38923882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7664882"/>
              </p:ext>
            </p:extLst>
          </p:nvPr>
        </p:nvGraphicFramePr>
        <p:xfrm>
          <a:off x="812800" y="5588003"/>
          <a:ext cx="10261600" cy="23545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032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44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848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06400">
                <a:tc>
                  <a:txBody>
                    <a:bodyPr/>
                    <a:lstStyle/>
                    <a:p>
                      <a:pPr algn="l"/>
                      <a:r>
                        <a:rPr lang="en-US" sz="1900" b="1" dirty="0"/>
                        <a:t>Primer Name</a:t>
                      </a:r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900" b="1" dirty="0"/>
                        <a:t>Sequence</a:t>
                      </a:r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/>
                        <a:t>Notes</a:t>
                      </a:r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55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F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500" dirty="0"/>
                        <a:t>GGGCAAAAGGTGTAGGAGAAA</a:t>
                      </a:r>
                    </a:p>
                  </a:txBody>
                  <a:tcPr marL="12700" marR="12700" marT="1270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loning of </a:t>
                      </a:r>
                      <a:r>
                        <a:rPr lang="en-US" sz="13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.</a:t>
                      </a:r>
                      <a:r>
                        <a:rPr lang="en-US" sz="13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mplementation and verification of </a:t>
                      </a:r>
                      <a:r>
                        <a:rPr lang="en-US" sz="13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 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tants.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56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cap="all" baseline="0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gttccccagtttttcaattc</a:t>
                      </a:r>
                      <a:endParaRPr lang="en-US" sz="1500" b="0" i="0" u="none" strike="noStrike" cap="all" baseline="0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loning of </a:t>
                      </a:r>
                      <a:r>
                        <a:rPr lang="en-US" sz="13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.</a:t>
                      </a:r>
                      <a:r>
                        <a:rPr lang="en-US" sz="13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mplementation and verification of </a:t>
                      </a:r>
                      <a:r>
                        <a:rPr lang="en-US" sz="13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 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tants.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C106 </a:t>
                      </a:r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F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cap="all" baseline="0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gtcgagaaaagtggggaga</a:t>
                      </a:r>
                      <a:endParaRPr lang="en-US" sz="1500" b="0" i="0" u="none" strike="noStrike" cap="all" baseline="0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alysis of </a:t>
                      </a:r>
                      <a:r>
                        <a:rPr lang="en-US" sz="13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 </a:t>
                      </a: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pression.</a:t>
                      </a: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107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cap="all" baseline="0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cttcttgcccctactcca</a:t>
                      </a:r>
                      <a:endParaRPr lang="en-US" sz="1500" b="0" i="0" u="none" strike="noStrike" cap="all" baseline="0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alysis of </a:t>
                      </a:r>
                      <a:r>
                        <a:rPr lang="en-US" sz="13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 </a:t>
                      </a: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pression.</a:t>
                      </a: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s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T_F</a:t>
                      </a:r>
                      <a:endParaRPr lang="en-US" sz="15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500" cap="all" baseline="0" dirty="0"/>
                        <a:t>TTGAGCGATTTACTTCGGTAAAGA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alysis of </a:t>
                      </a:r>
                      <a:r>
                        <a:rPr lang="en-US" sz="13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s </a:t>
                      </a: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pression – housekeeping gene.</a:t>
                      </a: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s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T_R</a:t>
                      </a:r>
                      <a:endParaRPr lang="en-US" sz="15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500" cap="all" baseline="0" dirty="0"/>
                        <a:t>CCATCCTGTACTGGCTCACC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alysis of </a:t>
                      </a:r>
                      <a:r>
                        <a:rPr lang="en-US" sz="13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s </a:t>
                      </a: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pression – housekeeping gene.</a:t>
                      </a: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BS universal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/>
                      <a:endParaRPr lang="en-US" sz="1500" dirty="0"/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etection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of </a:t>
                      </a:r>
                      <a:r>
                        <a:rPr lang="en-US" sz="13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losTron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intron and confirmation of </a:t>
                      </a:r>
                      <a:r>
                        <a:rPr lang="en-US" sz="13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 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tants.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/>
                      <a:endParaRPr lang="en-US" sz="1500" dirty="0"/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04800" y="1422400"/>
            <a:ext cx="9601200" cy="28829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4267" b="1" dirty="0"/>
          </a:p>
          <a:p>
            <a:endParaRPr lang="en-US" sz="4267" b="1" dirty="0"/>
          </a:p>
          <a:p>
            <a:endParaRPr lang="en-US" b="1" dirty="0"/>
          </a:p>
          <a:p>
            <a:endParaRPr lang="en-US" b="1" dirty="0"/>
          </a:p>
          <a:p>
            <a:r>
              <a:rPr lang="en-US" b="1" dirty="0"/>
              <a:t>Table S4.  Primers and Plasmids used in this study</a:t>
            </a:r>
          </a:p>
        </p:txBody>
      </p:sp>
      <p:graphicFrame>
        <p:nvGraphicFramePr>
          <p:cNvPr id="6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93938577"/>
              </p:ext>
            </p:extLst>
          </p:nvPr>
        </p:nvGraphicFramePr>
        <p:xfrm>
          <a:off x="812800" y="8432803"/>
          <a:ext cx="10160000" cy="16179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78356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37644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06400">
                <a:tc>
                  <a:txBody>
                    <a:bodyPr/>
                    <a:lstStyle/>
                    <a:p>
                      <a:pPr algn="l"/>
                      <a:r>
                        <a:rPr lang="en-US" sz="1900" b="1" dirty="0"/>
                        <a:t>Plasmid</a:t>
                      </a:r>
                      <a:r>
                        <a:rPr lang="en-US" sz="1900" b="1" baseline="0" dirty="0"/>
                        <a:t> Name</a:t>
                      </a:r>
                      <a:endParaRPr lang="en-US" sz="1900" b="1" dirty="0"/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/>
                        <a:t>Description</a:t>
                      </a:r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MTL82151</a:t>
                      </a:r>
                    </a:p>
                  </a:txBody>
                  <a:tcPr marL="12700" marR="12700" marT="12700" marB="0" anchor="b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mplementation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vector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MTL821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verexpression vector</a:t>
                      </a: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GemT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Easy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ub-cloning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vector containing the </a:t>
                      </a:r>
                      <a:r>
                        <a:rPr lang="en-US" sz="13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 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ene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MTL8215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mplementation vector with </a:t>
                      </a:r>
                      <a:r>
                        <a:rPr lang="en-US" sz="13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cloned into the MCS at </a:t>
                      </a:r>
                      <a:r>
                        <a:rPr lang="en-US" sz="1300" b="0" i="1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c</a:t>
                      </a:r>
                      <a:r>
                        <a:rPr lang="en-US" sz="13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/</a:t>
                      </a:r>
                      <a:r>
                        <a:rPr lang="en-US" sz="1300" b="0" i="1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c</a:t>
                      </a:r>
                      <a:r>
                        <a:rPr lang="en-US" sz="13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I</a:t>
                      </a:r>
                      <a:endParaRPr lang="en-US" sz="13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MTL82153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verexpression vector with </a:t>
                      </a:r>
                      <a:r>
                        <a:rPr lang="en-US" sz="13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 </a:t>
                      </a: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loned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into the MCS at </a:t>
                      </a:r>
                      <a:r>
                        <a:rPr lang="en-US" sz="1300" b="0" i="1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c</a:t>
                      </a:r>
                      <a:r>
                        <a:rPr lang="en-US" sz="13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/</a:t>
                      </a:r>
                      <a:r>
                        <a:rPr lang="en-US" sz="1300" b="0" i="1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co</a:t>
                      </a:r>
                      <a:r>
                        <a:rPr lang="en-US" sz="13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endParaRPr lang="en-US" sz="13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2810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067</TotalTime>
  <Words>360</Words>
  <Application>Microsoft Office PowerPoint</Application>
  <PresentationFormat>Custom</PresentationFormat>
  <Paragraphs>9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</dc:creator>
  <cp:lastModifiedBy>Carothers, Katelyn - (katelyncarothers)</cp:lastModifiedBy>
  <cp:revision>649</cp:revision>
  <cp:lastPrinted>2015-09-29T20:13:51Z</cp:lastPrinted>
  <dcterms:created xsi:type="dcterms:W3CDTF">2015-05-01T23:38:02Z</dcterms:created>
  <dcterms:modified xsi:type="dcterms:W3CDTF">2022-01-19T21:53:36Z</dcterms:modified>
</cp:coreProperties>
</file>